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6" r:id="rId4"/>
  </p:sldIdLst>
  <p:sldSz cx="6858000" cy="9902825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07" autoAdjust="0"/>
    <p:restoredTop sz="94660"/>
  </p:normalViewPr>
  <p:slideViewPr>
    <p:cSldViewPr snapToGrid="0">
      <p:cViewPr>
        <p:scale>
          <a:sx n="106" d="100"/>
          <a:sy n="106" d="100"/>
        </p:scale>
        <p:origin x="35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0798"/>
            <a:ext cx="5143500" cy="34479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1683"/>
            <a:ext cx="5143500" cy="23910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275"/>
            <a:ext cx="1478756" cy="839284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75"/>
            <a:ext cx="4350544" cy="839284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023"/>
            <a:ext cx="5915025" cy="411962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7618"/>
            <a:ext cx="5915025" cy="21664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6375"/>
            <a:ext cx="2914650" cy="628374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6375"/>
            <a:ext cx="2914650" cy="628374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75"/>
            <a:ext cx="5915025" cy="191423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7758"/>
            <a:ext cx="2901255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7565"/>
            <a:ext cx="2901255" cy="532089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7758"/>
            <a:ext cx="2915543" cy="118980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7565"/>
            <a:ext cx="2915543" cy="532089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211883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5935"/>
            <a:ext cx="3471863" cy="70379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211883" cy="550429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75"/>
            <a:ext cx="5915025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375"/>
            <a:ext cx="5915025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170"/>
            <a:ext cx="2314575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36525" y="3234690"/>
            <a:ext cx="6584315" cy="152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1. Meta analysis of single gene mutations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A) 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eta analysis of associations between </a:t>
            </a:r>
            <a:r>
              <a:rPr lang="en-US" altLang="zh-CN" sz="14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BRCA1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utation and progress-free survival. 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B) 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eta analysis of associations between </a:t>
            </a:r>
            <a:r>
              <a:rPr lang="en-US" altLang="zh-CN" sz="14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BRCA2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utation and progress-free survival. 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C)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eta analysis of associations between </a:t>
            </a:r>
            <a:r>
              <a:rPr lang="en-US" altLang="zh-CN" sz="14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P53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utation and progress-free survival. 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D)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eta analysis of associations between </a:t>
            </a:r>
            <a:r>
              <a:rPr lang="en-US" altLang="zh-CN" sz="14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TK11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utation and progress-free survival. </a:t>
            </a:r>
            <a:endParaRPr lang="en-US" altLang="zh-CN" sz="1400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just"/>
            <a:endParaRPr lang="en-US" altLang="zh-CN" sz="1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103" name="图片 102"/>
          <p:cNvPicPr/>
          <p:nvPr/>
        </p:nvPicPr>
        <p:blipFill>
          <a:blip r:embed="rId1"/>
          <a:stretch>
            <a:fillRect/>
          </a:stretch>
        </p:blipFill>
        <p:spPr>
          <a:xfrm>
            <a:off x="296545" y="508000"/>
            <a:ext cx="6264910" cy="256349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/>
        </p:nvSpPr>
        <p:spPr>
          <a:xfrm>
            <a:off x="147320" y="5447030"/>
            <a:ext cx="6584400" cy="1168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2. (A) S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bgroup analysis of </a:t>
            </a:r>
            <a:r>
              <a:rPr lang="en-US" altLang="zh-CN" sz="14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TM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utation and OS on the Gandara_2018 dataset. 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B)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The Kaplan Meier curve of </a:t>
            </a:r>
            <a:r>
              <a:rPr lang="en-US" altLang="zh-CN" sz="14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TK11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utation for overall survival in patients with </a:t>
            </a:r>
            <a:r>
              <a:rPr lang="en-US" altLang="zh-CN" sz="14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tezolizumab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Docetaxel on the Gandara_2018 dataset, respectively. 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C)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he univariable and multivariable cox regression of </a:t>
            </a:r>
            <a:r>
              <a:rPr lang="en-US" sz="1400" i="1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TGFBR2</a:t>
            </a:r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mutation with PFS on the Gandara_2018 dataset.</a:t>
            </a:r>
            <a:endParaRPr lang="zh-CN" altLang="en-US" sz="14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 descr="IMPACT_Figures2-6（2）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30580" y="320675"/>
            <a:ext cx="5217795" cy="489394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WRlNjQ3YzhkZjViMjFlYWM5NTQ3ZGYyZmQ1NGUzYjQifQ=="/>
  <p:tag name="KSO_WPP_MARK_KEY" val="c0c32ae1-301d-40c0-a83f-023acc93bb64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7</Words>
  <Application>WPS 演示</Application>
  <PresentationFormat>Custom</PresentationFormat>
  <Paragraphs>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赵晶-早检医学市场部</dc:creator>
  <cp:lastModifiedBy>赵晶</cp:lastModifiedBy>
  <cp:revision>78</cp:revision>
  <dcterms:created xsi:type="dcterms:W3CDTF">2022-09-20T07:29:00Z</dcterms:created>
  <dcterms:modified xsi:type="dcterms:W3CDTF">2023-07-19T05:44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424E591552345F28A8A2A2346303E06</vt:lpwstr>
  </property>
  <property fmtid="{D5CDD505-2E9C-101B-9397-08002B2CF9AE}" pid="3" name="KSOProductBuildVer">
    <vt:lpwstr>2052-11.1.0.14309</vt:lpwstr>
  </property>
</Properties>
</file>